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8" r:id="rId2"/>
    <p:sldId id="256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96" d="100"/>
          <a:sy n="96" d="100"/>
        </p:scale>
        <p:origin x="33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F00F2-FFDC-3049-B95D-F9920117189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2EC6-C0B0-D545-BF57-1F7D98B57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2486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F00F2-FFDC-3049-B95D-F9920117189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2EC6-C0B0-D545-BF57-1F7D98B57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672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F00F2-FFDC-3049-B95D-F9920117189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2EC6-C0B0-D545-BF57-1F7D98B57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67721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F00F2-FFDC-3049-B95D-F9920117189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2EC6-C0B0-D545-BF57-1F7D98B57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2463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F00F2-FFDC-3049-B95D-F9920117189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2EC6-C0B0-D545-BF57-1F7D98B57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354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F00F2-FFDC-3049-B95D-F9920117189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2EC6-C0B0-D545-BF57-1F7D98B57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9157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F00F2-FFDC-3049-B95D-F9920117189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2EC6-C0B0-D545-BF57-1F7D98B57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6242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F00F2-FFDC-3049-B95D-F9920117189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2EC6-C0B0-D545-BF57-1F7D98B57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9721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F00F2-FFDC-3049-B95D-F9920117189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2EC6-C0B0-D545-BF57-1F7D98B57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884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F00F2-FFDC-3049-B95D-F9920117189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2EC6-C0B0-D545-BF57-1F7D98B57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25029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F00F2-FFDC-3049-B95D-F9920117189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2EC6-C0B0-D545-BF57-1F7D98B57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7790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DF00F2-FFDC-3049-B95D-F9920117189D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662EC6-C0B0-D545-BF57-1F7D98B57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0168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BEB927C-8142-134C-AA4C-8D5C91A4FD9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57680" y="171704"/>
            <a:ext cx="3239873" cy="182242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DAC01C92-00EB-B74F-8CD0-77643D192D6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20077" y="1953315"/>
            <a:ext cx="3239873" cy="182242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83D51D12-3B7A-5548-9D9E-8654BC075C7A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20076" y="3775744"/>
            <a:ext cx="2952227" cy="492037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DC203CE-4CB2-1242-926A-FCC621B04A93}"/>
              </a:ext>
            </a:extLst>
          </p:cNvPr>
          <p:cNvSpPr txBox="1"/>
          <p:nvPr/>
        </p:nvSpPr>
        <p:spPr>
          <a:xfrm>
            <a:off x="2142287" y="8696122"/>
            <a:ext cx="2127505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4E6B32B-2ABD-934E-A48B-2658C37D8928}"/>
              </a:ext>
            </a:extLst>
          </p:cNvPr>
          <p:cNvSpPr txBox="1"/>
          <p:nvPr/>
        </p:nvSpPr>
        <p:spPr>
          <a:xfrm>
            <a:off x="207414" y="214219"/>
            <a:ext cx="311207" cy="369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2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67B1524-C871-7A47-8B4A-CFC11338DDDE}"/>
              </a:ext>
            </a:extLst>
          </p:cNvPr>
          <p:cNvSpPr txBox="1"/>
          <p:nvPr/>
        </p:nvSpPr>
        <p:spPr>
          <a:xfrm>
            <a:off x="207413" y="3775744"/>
            <a:ext cx="311207" cy="369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2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4863242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A32686F-0FAD-6542-B1B5-9BA41577F49C}"/>
              </a:ext>
            </a:extLst>
          </p:cNvPr>
          <p:cNvSpPr txBox="1"/>
          <p:nvPr/>
        </p:nvSpPr>
        <p:spPr>
          <a:xfrm>
            <a:off x="301487" y="303577"/>
            <a:ext cx="625502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Supplementary Figure 12. The impact of BAZ1A on gene expression. A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ell transfected with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BAZ1A cDNA had elevated expression.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B.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GSEA terms identified and visualized where the normalized enrichment score.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1532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</TotalTime>
  <Words>41</Words>
  <Application>Microsoft Macintosh PowerPoint</Application>
  <PresentationFormat>Letter Paper (8.5x11 in)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ay Campbell</dc:creator>
  <cp:lastModifiedBy>Moray Campbell</cp:lastModifiedBy>
  <cp:revision>1</cp:revision>
  <dcterms:created xsi:type="dcterms:W3CDTF">2023-02-21T20:02:08Z</dcterms:created>
  <dcterms:modified xsi:type="dcterms:W3CDTF">2023-02-21T20:03:09Z</dcterms:modified>
</cp:coreProperties>
</file>